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46" d="100"/>
          <a:sy n="46" d="100"/>
        </p:scale>
        <p:origin x="2837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8764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828917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50358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43729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240534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99923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139418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94633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329770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78591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99680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71606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3F307F6E-6B55-4D29-8B55-F07D0DC1392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74179" y="0"/>
            <a:ext cx="4309642" cy="8689067"/>
          </a:xfrm>
          <a:prstGeom prst="rect">
            <a:avLst/>
          </a:prstGeom>
          <a:noFill/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1A076B32-8CA1-40AC-B24D-A05F392B812E}"/>
              </a:ext>
            </a:extLst>
          </p:cNvPr>
          <p:cNvSpPr/>
          <p:nvPr/>
        </p:nvSpPr>
        <p:spPr>
          <a:xfrm>
            <a:off x="0" y="8689067"/>
            <a:ext cx="6857999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GB" sz="1200" b="1" dirty="0">
                <a:latin typeface="Segoe UI" panose="020B0502040204020203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4.</a:t>
            </a:r>
            <a:r>
              <a:rPr lang="en-GB" sz="1200" dirty="0">
                <a:latin typeface="Segoe UI" panose="020B0502040204020203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A) Plant phenotype of </a:t>
            </a:r>
            <a:r>
              <a:rPr lang="en-GB" sz="1200" i="1" dirty="0">
                <a:latin typeface="Segoe UI" panose="020B0502040204020203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slf3</a:t>
            </a:r>
            <a:r>
              <a:rPr lang="en-GB" sz="1200" dirty="0">
                <a:latin typeface="Segoe UI" panose="020B0502040204020203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utants growing in the glasshouse at 10 weeks old. Each gene-edited line (left) was compared to </a:t>
            </a:r>
            <a:r>
              <a:rPr lang="en-GB" sz="1200" i="1" dirty="0">
                <a:latin typeface="Segoe UI" panose="020B0502040204020203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v</a:t>
            </a:r>
            <a:r>
              <a:rPr lang="en-GB" sz="1200" dirty="0">
                <a:latin typeface="Segoe UI" panose="020B0502040204020203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Golden Promise (right). Below, mature grain phenotype harvested from the same lines. (B) Phenotypic assessment of grain characteristics: thousand grain weight (TGW), overall grain area, grain width and grain length for </a:t>
            </a:r>
            <a:r>
              <a:rPr lang="en-GB" sz="1200" i="1" dirty="0">
                <a:latin typeface="Segoe UI" panose="020B0502040204020203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slf3 </a:t>
            </a:r>
            <a:r>
              <a:rPr lang="en-GB" sz="1200" dirty="0">
                <a:latin typeface="Segoe UI" panose="020B0502040204020203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utants. Asterisks indicate statistically signiﬁcant differences compared to the control (WT) at P &lt; 0.05 (*) and P &lt; 0.01 (**) using Tukey’s post-hoc test.</a:t>
            </a:r>
            <a:endParaRPr lang="en-GB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691090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</TotalTime>
  <Words>101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egoe U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uillermo Garcia</dc:creator>
  <cp:lastModifiedBy>Guillermo Garcia</cp:lastModifiedBy>
  <cp:revision>9</cp:revision>
  <dcterms:created xsi:type="dcterms:W3CDTF">2020-05-14T00:51:09Z</dcterms:created>
  <dcterms:modified xsi:type="dcterms:W3CDTF">2020-05-14T01:33:39Z</dcterms:modified>
</cp:coreProperties>
</file>